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slides/slide1.xml" ContentType="application/vnd.openxmlformats-officedocument.presentationml.slide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Layouts/slideLayout1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1.xml" ContentType="application/vnd.openxmlformats-officedocument.theme+xml"/>
  <Override PartName="/ppt/viewProps.xml" ContentType="application/vnd.openxmlformats-officedocument.presentationml.viewProps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7FAEE4-C1DF-B92E-07E0-C7FEA4F317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E1F34AE-5D8E-3B64-EEC7-C56900100C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2B69B5-68E4-7354-16C7-C4B814185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2BF969-9970-87C5-7D95-3D38A49D5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AEB295-C7AB-ECA9-CFCE-80E0D51DE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381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3A8569A-35E5-0530-F631-7CFF0A0A22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DB3379-9712-08CF-9487-7135D1FD24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437E92-7D2C-2BB0-CAE3-718122C06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586CE5-F398-0F90-713C-C066C0C2B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135654-E3EB-41CF-9651-0654254B9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9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EA1F8E2-0B55-83E7-CC66-2FB37D7EC8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09AAD51-FE57-76F4-67CE-1B31B8B5AC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86CBA7-F3F0-FD58-8D0D-34D15BED4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7BA064E-8D30-B5EE-26C4-C99AD758B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AC1649-2EAC-FEAA-1D0B-77566CD22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971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958D7B-F839-6086-C651-D31340EF6D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E17B04A-EF1C-E482-DA77-9EA9662258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3C6D25-614E-5AC4-C35C-E44653DEE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2502D5-B9B5-FA88-0451-63A00F1D46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A0AFC0-AEAB-CD4D-A9A4-5D2544B32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7775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F286A4-AD53-AFD0-E3BF-88383E2EA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966E926-06ED-676E-0DC2-EF1377547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43906B-59A2-BC05-EB79-70453C75A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FA9F3C-1F8E-247D-EAF6-2D125C8CB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DE2A0BE-CC8A-D99B-9DFF-6F8BEBC141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7313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9DF489-B65B-4575-C122-FC5CE02B49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4DD78E4-FD2D-EB31-C9BE-3812AB8736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7842ED6-759D-4DAB-D6CA-A7E42F1B71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9064C9F-D7B3-411A-D4C6-39BBF4E42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D27CAA3-773A-5CB3-8FEE-49B411093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048EC53-76A6-8F03-CD4C-C63351874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572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E3D8C8-4FF7-226F-26B7-F6A026233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9F2230A-3319-3816-8802-5162113A1E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8682660-AB6D-F58E-BB6F-D81B29B3C5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6EC28FC-209D-6B13-8F4C-8763244136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58ED561-6D47-79B6-ED42-CB443365EF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DE894B7-3937-E127-B85F-6D2133C00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1CE43E8-890D-1082-5860-B4A12F076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B04814A-E3AD-F54C-A310-03E123B0F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510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23B096-327E-019B-093E-A8A03AFD9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B2A25B-5077-F25F-605C-324B2F655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901EFC4-EF84-6F96-ABBC-EB2DF0D9D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D6E392D-018C-79C5-FF14-DD476456F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6886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124063D-9438-62F1-371F-4972A24F7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D23A905-CD42-147B-9D0C-85E14A9E3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FF7A374-AC06-142B-C43B-8649C1AC3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589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BE443E-835A-5296-78A5-879197C03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E8F4441-CE05-9814-5E55-074B880F93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FF3E6B-AAF3-9AE7-E7F2-D07F0E118C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B013FF3-763A-C2B1-31AA-B0743EE10D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E98EED-5FAC-F4DE-072E-71676961E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85F1602-4659-DD42-4049-7F9D6BBCE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5078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02BD1C0-9771-FD78-BB29-678436F67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55AC8BF-22E5-D2A2-E975-0C313D7353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674456-EE36-F59A-1B4F-DAD139323F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7FC339E-5C84-70B5-7680-F0FEF09E9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3BA80FB-B23A-E2C8-3F0E-52E753912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C502A69-8CAE-65D0-172E-2C2F51D91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523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180838C-4E26-DEFD-5FCB-7C4230711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8475F3D-F621-A5CD-B648-18B15B3834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1A08F4-F94D-D7FD-4AF3-9FBF117C0A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65F449-A243-4215-BEE9-A8AD8EFD909B}" type="datetimeFigureOut">
              <a:rPr kumimoji="1" lang="ja-JP" altLang="en-US" smtClean="0"/>
              <a:t>2024/5/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44E7FD2-1F65-9A49-A5AF-0CCF3FE375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DF86F8F-88C2-C2C5-A575-AD86274401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25263-EB50-4DC5-9593-C78059B34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921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226127CE-16A9-7FBF-92FF-CFBA2C67B6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7316" y="716197"/>
            <a:ext cx="4039287" cy="237995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78538BD-F8A7-3B3F-AC17-A3E4EDD4CD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9313" y="683372"/>
            <a:ext cx="4091654" cy="2412781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BE96DC3A-0052-0FEE-E81A-7FD45F8CE4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27690" y="3427148"/>
            <a:ext cx="3998913" cy="2356167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D1813F98-C715-136A-306A-E9C5F2F169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69313" y="3370535"/>
            <a:ext cx="4094998" cy="241278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9584588-FCD0-DFD8-0437-7B5C3F4A3385}"/>
              </a:ext>
            </a:extLst>
          </p:cNvPr>
          <p:cNvSpPr txBox="1"/>
          <p:nvPr/>
        </p:nvSpPr>
        <p:spPr>
          <a:xfrm>
            <a:off x="4126550" y="5968827"/>
            <a:ext cx="39388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igure 1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9184149-51F1-8B97-F161-9125599EB7D4}"/>
              </a:ext>
            </a:extLst>
          </p:cNvPr>
          <p:cNvSpPr txBox="1"/>
          <p:nvPr/>
        </p:nvSpPr>
        <p:spPr>
          <a:xfrm>
            <a:off x="6784384" y="396163"/>
            <a:ext cx="34853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F5E7FC2-C5EA-1C47-DAE6-B7719766E5D9}"/>
              </a:ext>
            </a:extLst>
          </p:cNvPr>
          <p:cNvSpPr txBox="1"/>
          <p:nvPr/>
        </p:nvSpPr>
        <p:spPr>
          <a:xfrm>
            <a:off x="1622894" y="365953"/>
            <a:ext cx="41248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タイトル 1">
            <a:extLst>
              <a:ext uri="{FF2B5EF4-FFF2-40B4-BE49-F238E27FC236}">
                <a16:creationId xmlns:a16="http://schemas.microsoft.com/office/drawing/2014/main" id="{60124FEC-AD4F-D344-C52D-FA6D63307538}"/>
              </a:ext>
            </a:extLst>
          </p:cNvPr>
          <p:cNvSpPr txBox="1">
            <a:spLocks/>
          </p:cNvSpPr>
          <p:nvPr/>
        </p:nvSpPr>
        <p:spPr>
          <a:xfrm>
            <a:off x="4594741" y="604422"/>
            <a:ext cx="766137" cy="200169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lang="en-US" altLang="ja-JP" sz="1000" b="1" i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</a:t>
            </a:r>
            <a:r>
              <a:rPr kumimoji="1" lang="en-US" altLang="ja-JP" sz="10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&lt;0.001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BF3E349E-DD7E-B0A9-7D21-768C9ECFA85A}"/>
              </a:ext>
            </a:extLst>
          </p:cNvPr>
          <p:cNvSpPr txBox="1"/>
          <p:nvPr/>
        </p:nvSpPr>
        <p:spPr>
          <a:xfrm>
            <a:off x="6784384" y="2987383"/>
            <a:ext cx="34853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タイトル 1">
            <a:extLst>
              <a:ext uri="{FF2B5EF4-FFF2-40B4-BE49-F238E27FC236}">
                <a16:creationId xmlns:a16="http://schemas.microsoft.com/office/drawing/2014/main" id="{9C633B61-344D-6E0D-53DF-A1F84D78441F}"/>
              </a:ext>
            </a:extLst>
          </p:cNvPr>
          <p:cNvSpPr txBox="1">
            <a:spLocks/>
          </p:cNvSpPr>
          <p:nvPr/>
        </p:nvSpPr>
        <p:spPr>
          <a:xfrm>
            <a:off x="3559842" y="4131610"/>
            <a:ext cx="1801036" cy="241193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lang="en-US" altLang="ja-JP" sz="900" b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Stromal </a:t>
            </a: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D-L1 (+) (n=46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26" name="タイトル 1">
            <a:extLst>
              <a:ext uri="{FF2B5EF4-FFF2-40B4-BE49-F238E27FC236}">
                <a16:creationId xmlns:a16="http://schemas.microsoft.com/office/drawing/2014/main" id="{258FD0A0-15E9-9041-A238-8946C4132074}"/>
              </a:ext>
            </a:extLst>
          </p:cNvPr>
          <p:cNvSpPr txBox="1">
            <a:spLocks/>
          </p:cNvSpPr>
          <p:nvPr/>
        </p:nvSpPr>
        <p:spPr>
          <a:xfrm>
            <a:off x="2111177" y="4989536"/>
            <a:ext cx="1801036" cy="241193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lang="en-US" altLang="ja-JP" sz="900" b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Stromal </a:t>
            </a: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D-L1 (-) (n=75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084A55A-6DBF-3485-0C35-7E6D4CB82B6E}"/>
              </a:ext>
            </a:extLst>
          </p:cNvPr>
          <p:cNvSpPr txBox="1"/>
          <p:nvPr/>
        </p:nvSpPr>
        <p:spPr>
          <a:xfrm>
            <a:off x="1622894" y="3022223"/>
            <a:ext cx="413933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タイトル 1">
            <a:extLst>
              <a:ext uri="{FF2B5EF4-FFF2-40B4-BE49-F238E27FC236}">
                <a16:creationId xmlns:a16="http://schemas.microsoft.com/office/drawing/2014/main" id="{C722773C-C500-06C3-4387-1CF79B6D4556}"/>
              </a:ext>
            </a:extLst>
          </p:cNvPr>
          <p:cNvSpPr txBox="1">
            <a:spLocks/>
          </p:cNvSpPr>
          <p:nvPr/>
        </p:nvSpPr>
        <p:spPr>
          <a:xfrm>
            <a:off x="4592056" y="3360777"/>
            <a:ext cx="768822" cy="219884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1" lang="en-US" altLang="ja-JP" sz="10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=0.0</a:t>
            </a:r>
            <a:r>
              <a:rPr lang="en-US" altLang="ja-JP" sz="1000" b="1" i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02</a:t>
            </a:r>
            <a:endParaRPr kumimoji="1" lang="en-US" altLang="ja-JP" sz="1000" b="1" i="1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29" name="タイトル 1">
            <a:extLst>
              <a:ext uri="{FF2B5EF4-FFF2-40B4-BE49-F238E27FC236}">
                <a16:creationId xmlns:a16="http://schemas.microsoft.com/office/drawing/2014/main" id="{79ACF238-4B6C-6591-43F1-61F3276F8ABE}"/>
              </a:ext>
            </a:extLst>
          </p:cNvPr>
          <p:cNvSpPr txBox="1">
            <a:spLocks/>
          </p:cNvSpPr>
          <p:nvPr/>
        </p:nvSpPr>
        <p:spPr>
          <a:xfrm>
            <a:off x="9884159" y="604422"/>
            <a:ext cx="766137" cy="200169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lang="en-US" altLang="ja-JP" sz="1000" b="1" i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</a:t>
            </a:r>
            <a:r>
              <a:rPr kumimoji="1" lang="en-US" altLang="ja-JP" sz="10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&lt;0.001</a:t>
            </a:r>
          </a:p>
        </p:txBody>
      </p:sp>
      <p:sp>
        <p:nvSpPr>
          <p:cNvPr id="30" name="タイトル 1">
            <a:extLst>
              <a:ext uri="{FF2B5EF4-FFF2-40B4-BE49-F238E27FC236}">
                <a16:creationId xmlns:a16="http://schemas.microsoft.com/office/drawing/2014/main" id="{C4A6EB41-BDA3-58D7-39BF-1D16AFE79D23}"/>
              </a:ext>
            </a:extLst>
          </p:cNvPr>
          <p:cNvSpPr txBox="1">
            <a:spLocks/>
          </p:cNvSpPr>
          <p:nvPr/>
        </p:nvSpPr>
        <p:spPr>
          <a:xfrm>
            <a:off x="9882816" y="3360777"/>
            <a:ext cx="768822" cy="219884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1" lang="en-US" altLang="ja-JP" sz="1000" b="1" i="1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=0.0</a:t>
            </a:r>
            <a:r>
              <a:rPr lang="en-US" altLang="ja-JP" sz="1000" b="1" i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01</a:t>
            </a:r>
            <a:endParaRPr kumimoji="1" lang="en-US" altLang="ja-JP" sz="1000" b="1" i="1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11" name="タイトル 1">
            <a:extLst>
              <a:ext uri="{FF2B5EF4-FFF2-40B4-BE49-F238E27FC236}">
                <a16:creationId xmlns:a16="http://schemas.microsoft.com/office/drawing/2014/main" id="{8A17B859-A0DE-9E7A-264F-2EB2370D645E}"/>
              </a:ext>
            </a:extLst>
          </p:cNvPr>
          <p:cNvSpPr txBox="1">
            <a:spLocks/>
          </p:cNvSpPr>
          <p:nvPr/>
        </p:nvSpPr>
        <p:spPr>
          <a:xfrm>
            <a:off x="7174927" y="4972665"/>
            <a:ext cx="1781044" cy="243768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lang="en-US" altLang="ja-JP" sz="900" b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Stromal </a:t>
            </a: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D-L1 (-) (n=75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12" name="タイトル 1">
            <a:extLst>
              <a:ext uri="{FF2B5EF4-FFF2-40B4-BE49-F238E27FC236}">
                <a16:creationId xmlns:a16="http://schemas.microsoft.com/office/drawing/2014/main" id="{8FF8972D-76C2-A4D6-65D3-3EE303CFB6B1}"/>
              </a:ext>
            </a:extLst>
          </p:cNvPr>
          <p:cNvSpPr txBox="1">
            <a:spLocks/>
          </p:cNvSpPr>
          <p:nvPr/>
        </p:nvSpPr>
        <p:spPr>
          <a:xfrm>
            <a:off x="8314522" y="3856273"/>
            <a:ext cx="1872974" cy="243768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lang="en-US" altLang="ja-JP" sz="900" b="1" dirty="0">
                <a:solidFill>
                  <a:srgbClr val="000000"/>
                </a:solidFill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Stromal </a:t>
            </a: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PD-L1 (+) (n=46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7" name="タイトル 1">
            <a:extLst>
              <a:ext uri="{FF2B5EF4-FFF2-40B4-BE49-F238E27FC236}">
                <a16:creationId xmlns:a16="http://schemas.microsoft.com/office/drawing/2014/main" id="{09F10DD5-06B3-EFC3-CE58-EFB2AC5E141F}"/>
              </a:ext>
            </a:extLst>
          </p:cNvPr>
          <p:cNvSpPr txBox="1">
            <a:spLocks/>
          </p:cNvSpPr>
          <p:nvPr/>
        </p:nvSpPr>
        <p:spPr>
          <a:xfrm>
            <a:off x="3559842" y="1321239"/>
            <a:ext cx="1542052" cy="200169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CAF-PDPN (+) (n=50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8" name="タイトル 1">
            <a:extLst>
              <a:ext uri="{FF2B5EF4-FFF2-40B4-BE49-F238E27FC236}">
                <a16:creationId xmlns:a16="http://schemas.microsoft.com/office/drawing/2014/main" id="{EF00AC13-2D0D-9869-6B79-D654F06A2FB2}"/>
              </a:ext>
            </a:extLst>
          </p:cNvPr>
          <p:cNvSpPr txBox="1">
            <a:spLocks/>
          </p:cNvSpPr>
          <p:nvPr/>
        </p:nvSpPr>
        <p:spPr>
          <a:xfrm>
            <a:off x="2324858" y="2438171"/>
            <a:ext cx="1542052" cy="200169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CAF-PDPN (-) (n=71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9" name="タイトル 1">
            <a:extLst>
              <a:ext uri="{FF2B5EF4-FFF2-40B4-BE49-F238E27FC236}">
                <a16:creationId xmlns:a16="http://schemas.microsoft.com/office/drawing/2014/main" id="{EA4D1ECF-379F-84BB-4A9E-10362782C81F}"/>
              </a:ext>
            </a:extLst>
          </p:cNvPr>
          <p:cNvSpPr txBox="1">
            <a:spLocks/>
          </p:cNvSpPr>
          <p:nvPr/>
        </p:nvSpPr>
        <p:spPr>
          <a:xfrm>
            <a:off x="8645444" y="1233716"/>
            <a:ext cx="1542052" cy="200169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CAF-PDPN (+) (n=50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  <p:sp>
        <p:nvSpPr>
          <p:cNvPr id="15" name="タイトル 1">
            <a:extLst>
              <a:ext uri="{FF2B5EF4-FFF2-40B4-BE49-F238E27FC236}">
                <a16:creationId xmlns:a16="http://schemas.microsoft.com/office/drawing/2014/main" id="{199E2D62-8A85-6ABD-34EB-6AE0F3618A27}"/>
              </a:ext>
            </a:extLst>
          </p:cNvPr>
          <p:cNvSpPr txBox="1">
            <a:spLocks/>
          </p:cNvSpPr>
          <p:nvPr/>
        </p:nvSpPr>
        <p:spPr>
          <a:xfrm>
            <a:off x="7370606" y="2381907"/>
            <a:ext cx="1542052" cy="200169"/>
          </a:xfrm>
          <a:prstGeom prst="rect">
            <a:avLst/>
          </a:prstGeom>
          <a:solidFill>
            <a:srgbClr val="FFFFFF"/>
          </a:solidFill>
        </p:spPr>
        <p:txBody>
          <a:bodyPr vert="horz" lIns="91440" tIns="45720" rIns="91440" bIns="4572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>
                <a:srgbClr val="000000"/>
              </a:buClr>
              <a:buSzTx/>
              <a:buFont typeface="Arial"/>
              <a:buNone/>
              <a:tabLst/>
              <a:defRPr/>
            </a:pPr>
            <a:r>
              <a:rPr kumimoji="1" lang="en-US" altLang="ja-JP" sz="9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Meiryo UI" panose="020B0604030504040204" pitchFamily="50" charset="-128"/>
                <a:ea typeface="Meiryo UI" panose="020B0604030504040204" pitchFamily="50" charset="-128"/>
                <a:cs typeface="Calibri" panose="020F0502020204030204" pitchFamily="34" charset="0"/>
                <a:sym typeface="Arial"/>
              </a:rPr>
              <a:t>CAF-PDPN (-) (n=71)</a:t>
            </a:r>
            <a:endParaRPr kumimoji="1" lang="ja-JP" altLang="en-US" sz="9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Meiryo UI" panose="020B0604030504040204" pitchFamily="50" charset="-128"/>
              <a:ea typeface="Meiryo UI" panose="020B0604030504040204" pitchFamily="50" charset="-128"/>
              <a:cs typeface="Calibri" panose="020F050202020403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05311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90E7FC4D541B2849BA8638988FDB66F4" ma:contentTypeVersion="16" ma:contentTypeDescription="新しいドキュメントを作成します。" ma:contentTypeScope="" ma:versionID="9b674035cb64b6a992d2048c6ee7386a">
  <xsd:schema xmlns:xsd="http://www.w3.org/2001/XMLSchema" xmlns:xs="http://www.w3.org/2001/XMLSchema" xmlns:p="http://schemas.microsoft.com/office/2006/metadata/properties" xmlns:ns2="315829b0-8815-4a61-8a9d-852f0f698a04" xmlns:ns3="7e093de7-bcd5-4818-9426-fff709e5ffd9" targetNamespace="http://schemas.microsoft.com/office/2006/metadata/properties" ma:root="true" ma:fieldsID="6683e2ce9025a145312f0b1fa526d9ed" ns2:_="" ns3:_="">
    <xsd:import namespace="315829b0-8815-4a61-8a9d-852f0f698a04"/>
    <xsd:import namespace="7e093de7-bcd5-4818-9426-fff709e5ffd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AutoKeyPoints" minOccurs="0"/>
                <xsd:element ref="ns2:MediaServiceKeyPoint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15829b0-8815-4a61-8a9d-852f0f698a0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7" nillable="true" ma:taxonomy="true" ma:internalName="lcf76f155ced4ddcb4097134ff3c332f" ma:taxonomyFieldName="MediaServiceImageTags" ma:displayName="画像タグ" ma:readOnly="false" ma:fieldId="{5cf76f15-5ced-4ddc-b409-7134ff3c332f}" ma:taxonomyMulti="true" ma:sspId="7bdb6d41-5de2-472b-ab6e-3f14edb75ab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MediaServiceAutoKeyPoints" ma:index="2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093de7-bcd5-4818-9426-fff709e5ffd9" elementFormDefault="qualified">
    <xsd:import namespace="http://schemas.microsoft.com/office/2006/documentManagement/types"/>
    <xsd:import namespace="http://schemas.microsoft.com/office/infopath/2007/PartnerControls"/>
    <xsd:element name="TaxCatchAll" ma:index="18" nillable="true" ma:displayName="Taxonomy Catch All Column" ma:hidden="true" ma:list="{8e40dff3-1a55-4a41-9761-6daa6b31d349}" ma:internalName="TaxCatchAll" ma:showField="CatchAllData" ma:web="7e093de7-bcd5-4818-9426-fff709e5ffd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15829b0-8815-4a61-8a9d-852f0f698a04">
      <Terms xmlns="http://schemas.microsoft.com/office/infopath/2007/PartnerControls"/>
    </lcf76f155ced4ddcb4097134ff3c332f>
    <TaxCatchAll xmlns="7e093de7-bcd5-4818-9426-fff709e5ffd9" xsi:nil="true"/>
  </documentManagement>
</p:properties>
</file>

<file path=customXml/itemProps1.xml><?xml version="1.0" encoding="utf-8"?>
<ds:datastoreItem xmlns:ds="http://schemas.openxmlformats.org/officeDocument/2006/customXml" ds:itemID="{2DBEBE63-63EF-4904-8044-F59458C7E019}"/>
</file>

<file path=customXml/itemProps2.xml><?xml version="1.0" encoding="utf-8"?>
<ds:datastoreItem xmlns:ds="http://schemas.openxmlformats.org/officeDocument/2006/customXml" ds:itemID="{4E124DF4-B37F-4DD3-BFB9-BDDF2E1DC424}"/>
</file>

<file path=customXml/itemProps3.xml><?xml version="1.0" encoding="utf-8"?>
<ds:datastoreItem xmlns:ds="http://schemas.openxmlformats.org/officeDocument/2006/customXml" ds:itemID="{E2E6BC9D-3D69-4B65-951F-AAFA51C6EA88}"/>
</file>

<file path=docProps/app.xml><?xml version="1.0" encoding="utf-8"?>
<Properties xmlns="http://schemas.openxmlformats.org/officeDocument/2006/extended-properties" xmlns:vt="http://schemas.openxmlformats.org/officeDocument/2006/docPropsVTypes">
  <TotalTime>562</TotalTime>
  <Words>79</Words>
  <Application>Microsoft Office PowerPoint</Application>
  <PresentationFormat>ワイド画面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eiryo UI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竜弥 宮本</dc:creator>
  <cp:lastModifiedBy>竜弥 宮本</cp:lastModifiedBy>
  <cp:revision>19</cp:revision>
  <dcterms:created xsi:type="dcterms:W3CDTF">2023-10-16T04:47:50Z</dcterms:created>
  <dcterms:modified xsi:type="dcterms:W3CDTF">2024-05-04T04:17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0E7FC4D541B2849BA8638988FDB66F4</vt:lpwstr>
  </property>
</Properties>
</file>